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4" r:id="rId5"/>
    <p:sldId id="265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3" autoAdjust="0"/>
    <p:restoredTop sz="94660"/>
  </p:normalViewPr>
  <p:slideViewPr>
    <p:cSldViewPr snapToGrid="0">
      <p:cViewPr varScale="1">
        <p:scale>
          <a:sx n="74" d="100"/>
          <a:sy n="74" d="100"/>
        </p:scale>
        <p:origin x="75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B364D7-CF36-4F1D-A1FE-955189F5A2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4798AAA-3A97-4BEB-8C0F-319A35B4C5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509D5C-C796-4FA5-8930-29FE35A3D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2F3098C-EA6B-4A8A-B687-58948AF1F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F0E831-0E0E-48CD-9332-B4E9AC4A3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38038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5ACA7A-0F23-4790-A43C-6D9E41D76F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E7F734-C2CC-453E-AC6D-9181DE0492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3DA34C5-871F-4F54-9EA9-A1E12A5EF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103944B-6413-4712-8AAE-D89FFE822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CC8AA85-114A-4773-87DA-F6A3D340B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2926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42615CE-90C6-4CBD-966E-952C399B0F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70ECA95-0E99-4508-8666-1A5604CCC2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E95EFC3-0B13-4D18-9A2B-3F917D4A0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F92D98-69A4-4213-A118-8EBB0DE0E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C9283F4-0C52-4DE7-A9A4-8129F56C6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73068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F25252-B02A-4835-9041-E86C176C61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948FD9D-A26A-42A3-9132-97B23E1CA8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F5C11D-DF56-433C-BF25-7E8D8DBF5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68B748-A1D8-4533-B0DD-FB225F2B0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88C1804-B517-4ACC-81D6-12150B621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2701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0ACEDF-D9E0-4197-8101-9788735DD8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6A3E745-9DB1-4790-9781-8DC7EFFB30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687D8F-799E-47D8-867E-55A269B59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90C9F7-E340-40F6-8F97-E610313F21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5DA96F-427B-4732-91FB-5B1A73FD8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31966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A40B82-38C5-41CA-B6B7-9EC89360F6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E1E3CAC-4687-4B9A-A623-87DCDBFBAC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71EF1DF-D6CC-4F01-B500-56DFA8F853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F56B4A6-F422-4B9C-B38E-ACF2DF13F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5C868DB-E008-4030-971B-F5214AD2E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33F1988-5ACB-48D7-8293-E22B9A051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28112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B741EA-0BF5-48DE-861B-CF4F76A2E6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94AE7F3-7EED-4D8F-AD1C-32048BCE0E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1CE6D78-48F8-406F-92C6-55DB57CCB0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A91C6BC-141D-4FDC-999B-C8E6560ADF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3B8856E-E8EC-4026-A0EB-A83CD322B6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C888084-30E6-4E96-91F2-DA5A6E08B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D4EB3E6-AFDD-477E-948F-4B992DCA9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5ECAB78-B10A-4DD9-A5F7-55A5B7190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41992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B48A89-6C47-4E29-AB8B-DDD772306D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D596C62-D0FD-4A84-8112-FA1E8DEBE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0C80E9E-5BDF-44BA-A76E-606DC693A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0A9A93A-D716-409C-BF5F-467631872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752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68A644F-959C-4603-81F2-A7BD9A7C2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24ED2F2-280D-4707-9FA2-96F2B5CF3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64D108A-BB51-402F-BC3B-CC74B46B0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32348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B52AF0B-3E3E-4AA3-92C6-F1D07F7931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678F105-F7E8-494A-B051-94BC64B289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179332F-F733-48AA-B6DC-CEE3C3BD8E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C9EACEF-E917-4D66-9DE9-B31E8647E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1B30117-0E8D-4E0E-98C9-81FD1E35A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D48E8CC-C06E-4108-8A43-B2C414CCA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38161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1CF776-98F5-4F41-8738-F7BD68C2BF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CAA906B-C93E-4431-84BC-723CC72191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903557-E922-4380-8F1A-11458C404D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2F8E1C5-A379-4A3C-98F1-7401690A9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257962D-C7F0-46BB-8726-A21BA997C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D5D00DD-2BD8-4221-923C-00A05CD47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39031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E29E536-BD9D-49C0-BF81-9961644FDD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541D64F-E303-4CFC-A3C2-677E9A0EAB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4FEA58-7755-43BB-BFA7-45CA0A89B3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F8CC55-AC84-4A31-8541-F0708101E9D2}" type="datetimeFigureOut">
              <a:rPr kumimoji="1" lang="ja-JP" altLang="en-US" smtClean="0"/>
              <a:t>2024/1/25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DF77E7F-6C64-493D-88C8-3ABAB011C9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D94C136-4A29-4010-AC41-B175FDAE06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2764E0-BD83-4D12-9B35-4EB4D4DDBC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64008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597FB8B-C5FC-417C-BD34-3F472C33989B}"/>
              </a:ext>
            </a:extLst>
          </p:cNvPr>
          <p:cNvSpPr txBox="1"/>
          <p:nvPr/>
        </p:nvSpPr>
        <p:spPr>
          <a:xfrm>
            <a:off x="644434" y="500588"/>
            <a:ext cx="59503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25D90DB-D175-47C8-AA76-18AF7536CF25}"/>
              </a:ext>
            </a:extLst>
          </p:cNvPr>
          <p:cNvSpPr txBox="1"/>
          <p:nvPr/>
        </p:nvSpPr>
        <p:spPr>
          <a:xfrm>
            <a:off x="4189278" y="500588"/>
            <a:ext cx="6463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63BB455-27E3-44E5-9E09-BC0A8CEB306D}"/>
              </a:ext>
            </a:extLst>
          </p:cNvPr>
          <p:cNvSpPr txBox="1"/>
          <p:nvPr/>
        </p:nvSpPr>
        <p:spPr>
          <a:xfrm>
            <a:off x="7772594" y="500588"/>
            <a:ext cx="87716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MS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7EF1B25-5CE0-40DB-BFE3-16B676B44DBC}"/>
              </a:ext>
            </a:extLst>
          </p:cNvPr>
          <p:cNvSpPr txBox="1"/>
          <p:nvPr/>
        </p:nvSpPr>
        <p:spPr>
          <a:xfrm>
            <a:off x="644434" y="3809239"/>
            <a:ext cx="59503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745002D-D697-442B-B575-DF214DEFA309}"/>
              </a:ext>
            </a:extLst>
          </p:cNvPr>
          <p:cNvSpPr txBox="1"/>
          <p:nvPr/>
        </p:nvSpPr>
        <p:spPr>
          <a:xfrm>
            <a:off x="4189278" y="3807807"/>
            <a:ext cx="6463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C8FCC9E-D7B5-4F5B-BB6B-6E7B207BCFD9}"/>
              </a:ext>
            </a:extLst>
          </p:cNvPr>
          <p:cNvSpPr txBox="1"/>
          <p:nvPr/>
        </p:nvSpPr>
        <p:spPr>
          <a:xfrm>
            <a:off x="7772594" y="3807807"/>
            <a:ext cx="87716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MS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AC6AD73-1DB4-4F6B-BA2E-2FB274CFDE44}"/>
              </a:ext>
            </a:extLst>
          </p:cNvPr>
          <p:cNvSpPr txBox="1"/>
          <p:nvPr/>
        </p:nvSpPr>
        <p:spPr>
          <a:xfrm>
            <a:off x="3995560" y="913716"/>
            <a:ext cx="4475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9274E86-3397-4D79-BCFD-5A3C877A2939}"/>
              </a:ext>
            </a:extLst>
          </p:cNvPr>
          <p:cNvSpPr txBox="1"/>
          <p:nvPr/>
        </p:nvSpPr>
        <p:spPr>
          <a:xfrm>
            <a:off x="4094304" y="2851371"/>
            <a:ext cx="3529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FD188C0-4776-4403-AFD0-33091E64EE9C}"/>
              </a:ext>
            </a:extLst>
          </p:cNvPr>
          <p:cNvSpPr txBox="1"/>
          <p:nvPr/>
        </p:nvSpPr>
        <p:spPr>
          <a:xfrm rot="10800000">
            <a:off x="416763" y="1801503"/>
            <a:ext cx="307777" cy="27667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878DAA9-A307-4FAA-B644-BEC6E8C1CB5A}"/>
              </a:ext>
            </a:extLst>
          </p:cNvPr>
          <p:cNvSpPr txBox="1"/>
          <p:nvPr/>
        </p:nvSpPr>
        <p:spPr>
          <a:xfrm rot="10800000">
            <a:off x="7674827" y="1745932"/>
            <a:ext cx="307777" cy="40011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MS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1FED9A8-77BF-4C86-BAFA-9F75FE190BEE}"/>
              </a:ext>
            </a:extLst>
          </p:cNvPr>
          <p:cNvSpPr txBox="1"/>
          <p:nvPr/>
        </p:nvSpPr>
        <p:spPr>
          <a:xfrm>
            <a:off x="196598" y="80678"/>
            <a:ext cx="26920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myloid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beta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42/40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DBE8A6E-4E3D-49CB-86CE-DEADD41429B7}"/>
              </a:ext>
            </a:extLst>
          </p:cNvPr>
          <p:cNvSpPr txBox="1"/>
          <p:nvPr/>
        </p:nvSpPr>
        <p:spPr>
          <a:xfrm>
            <a:off x="222804" y="3435092"/>
            <a:ext cx="31486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hosphorylated tau181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0C1C60C-0F10-4326-8EF7-8429DE1B0F6E}"/>
              </a:ext>
            </a:extLst>
          </p:cNvPr>
          <p:cNvSpPr txBox="1"/>
          <p:nvPr/>
        </p:nvSpPr>
        <p:spPr>
          <a:xfrm>
            <a:off x="3998605" y="4310657"/>
            <a:ext cx="4475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32AB5F2-7897-450D-B530-16EC97944289}"/>
              </a:ext>
            </a:extLst>
          </p:cNvPr>
          <p:cNvSpPr txBox="1"/>
          <p:nvPr/>
        </p:nvSpPr>
        <p:spPr>
          <a:xfrm>
            <a:off x="4094304" y="6212454"/>
            <a:ext cx="3529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6E1A325-D08A-45AC-976B-FC2E85878905}"/>
              </a:ext>
            </a:extLst>
          </p:cNvPr>
          <p:cNvSpPr txBox="1"/>
          <p:nvPr/>
        </p:nvSpPr>
        <p:spPr>
          <a:xfrm rot="10800000">
            <a:off x="7674826" y="5195714"/>
            <a:ext cx="307777" cy="40011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MS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3D342B24-22D8-44E9-8015-F5DC39E373B6}"/>
              </a:ext>
            </a:extLst>
          </p:cNvPr>
          <p:cNvSpPr txBox="1"/>
          <p:nvPr/>
        </p:nvSpPr>
        <p:spPr>
          <a:xfrm rot="10800000">
            <a:off x="420720" y="5258366"/>
            <a:ext cx="307777" cy="27667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774424E-41D3-4A5E-85C8-487504862213}"/>
              </a:ext>
            </a:extLst>
          </p:cNvPr>
          <p:cNvSpPr txBox="1"/>
          <p:nvPr/>
        </p:nvSpPr>
        <p:spPr>
          <a:xfrm>
            <a:off x="0" y="6561836"/>
            <a:ext cx="20938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D979355B-9ABE-42A2-91AC-22BFA0EC808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1" t="1262" r="1092" b="1077"/>
          <a:stretch/>
        </p:blipFill>
        <p:spPr>
          <a:xfrm>
            <a:off x="731827" y="946068"/>
            <a:ext cx="2937164" cy="2272995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7FB1B4E5-D247-447C-A6BC-771B7C703C0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1" t="588" r="1053" b="821"/>
          <a:stretch/>
        </p:blipFill>
        <p:spPr>
          <a:xfrm>
            <a:off x="4463196" y="913716"/>
            <a:ext cx="2927214" cy="231161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B1921FEF-9F16-4607-A67D-EEAB7FA79A0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1" t="697" r="1227" b="821"/>
          <a:stretch/>
        </p:blipFill>
        <p:spPr>
          <a:xfrm>
            <a:off x="7982603" y="869920"/>
            <a:ext cx="2978049" cy="2353557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D07129EF-E101-490F-9D1B-4320AE288F2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1" t="1519" r="1053" b="1053"/>
          <a:stretch/>
        </p:blipFill>
        <p:spPr>
          <a:xfrm>
            <a:off x="736802" y="4277485"/>
            <a:ext cx="2927214" cy="2284351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D7B72BC1-B254-40F4-B544-15B15BBD50A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1" t="356" r="1227" b="1285"/>
          <a:stretch/>
        </p:blipFill>
        <p:spPr>
          <a:xfrm>
            <a:off x="4443118" y="4277485"/>
            <a:ext cx="2947292" cy="2326309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9D47FE79-C3C2-45FF-8CD4-8D0B95AD156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2" t="1309" r="1034" b="349"/>
          <a:stretch/>
        </p:blipFill>
        <p:spPr>
          <a:xfrm>
            <a:off x="8033438" y="4310657"/>
            <a:ext cx="2927214" cy="23053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49752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597FB8B-C5FC-417C-BD34-3F472C33989B}"/>
              </a:ext>
            </a:extLst>
          </p:cNvPr>
          <p:cNvSpPr txBox="1"/>
          <p:nvPr/>
        </p:nvSpPr>
        <p:spPr>
          <a:xfrm>
            <a:off x="644434" y="500588"/>
            <a:ext cx="59503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25D90DB-D175-47C8-AA76-18AF7536CF25}"/>
              </a:ext>
            </a:extLst>
          </p:cNvPr>
          <p:cNvSpPr txBox="1"/>
          <p:nvPr/>
        </p:nvSpPr>
        <p:spPr>
          <a:xfrm>
            <a:off x="4189278" y="500588"/>
            <a:ext cx="6463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63BB455-27E3-44E5-9E09-BC0A8CEB306D}"/>
              </a:ext>
            </a:extLst>
          </p:cNvPr>
          <p:cNvSpPr txBox="1"/>
          <p:nvPr/>
        </p:nvSpPr>
        <p:spPr>
          <a:xfrm>
            <a:off x="7772594" y="500588"/>
            <a:ext cx="87716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MS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7EF1B25-5CE0-40DB-BFE3-16B676B44DBC}"/>
              </a:ext>
            </a:extLst>
          </p:cNvPr>
          <p:cNvSpPr txBox="1"/>
          <p:nvPr/>
        </p:nvSpPr>
        <p:spPr>
          <a:xfrm>
            <a:off x="644434" y="3809239"/>
            <a:ext cx="59503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745002D-D697-442B-B575-DF214DEFA309}"/>
              </a:ext>
            </a:extLst>
          </p:cNvPr>
          <p:cNvSpPr txBox="1"/>
          <p:nvPr/>
        </p:nvSpPr>
        <p:spPr>
          <a:xfrm>
            <a:off x="4189278" y="3807807"/>
            <a:ext cx="6463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EX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C8FCC9E-D7B5-4F5B-BB6B-6E7B207BCFD9}"/>
              </a:ext>
            </a:extLst>
          </p:cNvPr>
          <p:cNvSpPr txBox="1"/>
          <p:nvPr/>
        </p:nvSpPr>
        <p:spPr>
          <a:xfrm>
            <a:off x="7772594" y="3807807"/>
            <a:ext cx="87716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MS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5B922D5-9AAD-468C-A814-F536F1949BC4}"/>
              </a:ext>
            </a:extLst>
          </p:cNvPr>
          <p:cNvSpPr txBox="1"/>
          <p:nvPr/>
        </p:nvSpPr>
        <p:spPr>
          <a:xfrm>
            <a:off x="0" y="6561836"/>
            <a:ext cx="20938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AC6AD73-1DB4-4F6B-BA2E-2FB274CFDE44}"/>
              </a:ext>
            </a:extLst>
          </p:cNvPr>
          <p:cNvSpPr txBox="1"/>
          <p:nvPr/>
        </p:nvSpPr>
        <p:spPr>
          <a:xfrm>
            <a:off x="3995560" y="876138"/>
            <a:ext cx="4475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9274E86-3397-4D79-BCFD-5A3C877A2939}"/>
              </a:ext>
            </a:extLst>
          </p:cNvPr>
          <p:cNvSpPr txBox="1"/>
          <p:nvPr/>
        </p:nvSpPr>
        <p:spPr>
          <a:xfrm>
            <a:off x="4094304" y="2851371"/>
            <a:ext cx="3529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FD188C0-4776-4403-AFD0-33091E64EE9C}"/>
              </a:ext>
            </a:extLst>
          </p:cNvPr>
          <p:cNvSpPr txBox="1"/>
          <p:nvPr/>
        </p:nvSpPr>
        <p:spPr>
          <a:xfrm rot="10800000">
            <a:off x="416763" y="1801503"/>
            <a:ext cx="307777" cy="27667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878DAA9-A307-4FAA-B644-BEC6E8C1CB5A}"/>
              </a:ext>
            </a:extLst>
          </p:cNvPr>
          <p:cNvSpPr txBox="1"/>
          <p:nvPr/>
        </p:nvSpPr>
        <p:spPr>
          <a:xfrm rot="10800000">
            <a:off x="7674827" y="1745932"/>
            <a:ext cx="307777" cy="40011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MS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0C1C60C-0F10-4326-8EF7-8429DE1B0F6E}"/>
              </a:ext>
            </a:extLst>
          </p:cNvPr>
          <p:cNvSpPr txBox="1"/>
          <p:nvPr/>
        </p:nvSpPr>
        <p:spPr>
          <a:xfrm>
            <a:off x="3998605" y="4185397"/>
            <a:ext cx="4475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32AB5F2-7897-450D-B530-16EC97944289}"/>
              </a:ext>
            </a:extLst>
          </p:cNvPr>
          <p:cNvSpPr txBox="1"/>
          <p:nvPr/>
        </p:nvSpPr>
        <p:spPr>
          <a:xfrm>
            <a:off x="4094304" y="6149659"/>
            <a:ext cx="3529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6E1A325-D08A-45AC-976B-FC2E85878905}"/>
              </a:ext>
            </a:extLst>
          </p:cNvPr>
          <p:cNvSpPr txBox="1"/>
          <p:nvPr/>
        </p:nvSpPr>
        <p:spPr>
          <a:xfrm rot="10800000">
            <a:off x="7674826" y="5195714"/>
            <a:ext cx="307777" cy="40011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MS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3D342B24-22D8-44E9-8015-F5DC39E373B6}"/>
              </a:ext>
            </a:extLst>
          </p:cNvPr>
          <p:cNvSpPr txBox="1"/>
          <p:nvPr/>
        </p:nvSpPr>
        <p:spPr>
          <a:xfrm rot="10800000">
            <a:off x="420720" y="5258366"/>
            <a:ext cx="307777" cy="27667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57C6427-44D7-4A84-A15E-B83F9804E81E}"/>
              </a:ext>
            </a:extLst>
          </p:cNvPr>
          <p:cNvSpPr txBox="1"/>
          <p:nvPr/>
        </p:nvSpPr>
        <p:spPr>
          <a:xfrm>
            <a:off x="196598" y="80678"/>
            <a:ext cx="33778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lial fibrillary acid protein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0466573-9CC3-4DE1-896A-5C8AF5AAB3D3}"/>
              </a:ext>
            </a:extLst>
          </p:cNvPr>
          <p:cNvSpPr txBox="1"/>
          <p:nvPr/>
        </p:nvSpPr>
        <p:spPr>
          <a:xfrm>
            <a:off x="222804" y="3435092"/>
            <a:ext cx="33345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eurofilament light chain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EA214F7A-B5CF-4EF1-B4BB-BC25D7BBFA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2" t="1185" r="1226" b="1142"/>
          <a:stretch/>
        </p:blipFill>
        <p:spPr>
          <a:xfrm>
            <a:off x="682360" y="897771"/>
            <a:ext cx="3050050" cy="2382167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C4AFFC52-EAA8-4BA9-9F4E-E64387E4BEB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58" t="1856" r="624" b="1183"/>
          <a:stretch/>
        </p:blipFill>
        <p:spPr>
          <a:xfrm>
            <a:off x="4446162" y="913716"/>
            <a:ext cx="2988405" cy="228952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7A7C0885-CF19-409C-8B02-17D905097A9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3" t="1309" r="418" b="2613"/>
          <a:stretch/>
        </p:blipFill>
        <p:spPr>
          <a:xfrm>
            <a:off x="7977666" y="897771"/>
            <a:ext cx="3050050" cy="230552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1B43704-00CF-48F7-9622-F733F369FC6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65" t="760" r="1034" b="6102"/>
          <a:stretch/>
        </p:blipFill>
        <p:spPr>
          <a:xfrm>
            <a:off x="682361" y="4228744"/>
            <a:ext cx="3050050" cy="2259296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2AE452FC-7ABE-4ECF-B119-8597133016F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7" t="1582" r="1035" b="6102"/>
          <a:stretch/>
        </p:blipFill>
        <p:spPr>
          <a:xfrm>
            <a:off x="4506177" y="4228743"/>
            <a:ext cx="2930867" cy="2128669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3CC358E3-5358-4900-9E96-FA043D7F616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8" t="487" r="1240" b="6375"/>
          <a:stretch/>
        </p:blipFill>
        <p:spPr>
          <a:xfrm>
            <a:off x="8045095" y="4185397"/>
            <a:ext cx="2930867" cy="2180513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A987F81-C279-4E77-B3DB-B1DCDFB58C7D}"/>
              </a:ext>
            </a:extLst>
          </p:cNvPr>
          <p:cNvSpPr txBox="1"/>
          <p:nvPr/>
        </p:nvSpPr>
        <p:spPr>
          <a:xfrm>
            <a:off x="1576967" y="6416536"/>
            <a:ext cx="11624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og Neurofilament light chai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E1CCC042-5056-4C09-97C3-485387D474C2}"/>
              </a:ext>
            </a:extLst>
          </p:cNvPr>
          <p:cNvSpPr txBox="1"/>
          <p:nvPr/>
        </p:nvSpPr>
        <p:spPr>
          <a:xfrm>
            <a:off x="5359115" y="6365910"/>
            <a:ext cx="11624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og Neurofilament light chai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FA093F9-ADB5-498F-961A-75978CF59CDC}"/>
              </a:ext>
            </a:extLst>
          </p:cNvPr>
          <p:cNvSpPr txBox="1"/>
          <p:nvPr/>
        </p:nvSpPr>
        <p:spPr>
          <a:xfrm>
            <a:off x="8921442" y="6355251"/>
            <a:ext cx="11624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og Neurofilament light chain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8022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C12D923ED91405498361AFD39CAD7452" ma:contentTypeVersion="11" ma:contentTypeDescription="新しいドキュメントを作成します。" ma:contentTypeScope="" ma:versionID="df687a11115ffb599834836cc2f01d40">
  <xsd:schema xmlns:xsd="http://www.w3.org/2001/XMLSchema" xmlns:xs="http://www.w3.org/2001/XMLSchema" xmlns:p="http://schemas.microsoft.com/office/2006/metadata/properties" xmlns:ns3="730f757a-0845-48d2-8e88-d1b41abe01ea" targetNamespace="http://schemas.microsoft.com/office/2006/metadata/properties" ma:root="true" ma:fieldsID="48c4fea95d434fb0e22fc330c61c4b30" ns3:_="">
    <xsd:import namespace="730f757a-0845-48d2-8e88-d1b41abe01e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LengthInSecond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30f757a-0845-48d2-8e88-d1b41abe01e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11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6" nillable="true" ma:displayName="Location" ma:indexed="true" ma:internalName="MediaServiceLocation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18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89A6C2A-973D-42F1-8954-CD406DFBD69C}">
  <ds:schemaRefs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schemas.openxmlformats.org/package/2006/metadata/core-properties"/>
    <ds:schemaRef ds:uri="http://purl.org/dc/elements/1.1/"/>
    <ds:schemaRef ds:uri="730f757a-0845-48d2-8e88-d1b41abe01ea"/>
    <ds:schemaRef ds:uri="http://schemas.microsoft.com/office/2006/metadata/propertie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917CCC4F-C5B8-4A69-951C-872D7FF34D4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EEB8E48-AA17-4DBB-A97B-DADD13125EA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30f757a-0845-48d2-8e88-d1b41abe01e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84</TotalTime>
  <Words>66</Words>
  <Application>Microsoft Office PowerPoint</Application>
  <PresentationFormat>ワイド画面</PresentationFormat>
  <Paragraphs>3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.Ohara</dc:creator>
  <cp:lastModifiedBy>OHARA TOMOYUKI</cp:lastModifiedBy>
  <cp:revision>40</cp:revision>
  <dcterms:created xsi:type="dcterms:W3CDTF">2023-06-12T06:52:39Z</dcterms:created>
  <dcterms:modified xsi:type="dcterms:W3CDTF">2024-01-25T06:10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12D923ED91405498361AFD39CAD7452</vt:lpwstr>
  </property>
</Properties>
</file>